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2389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677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4660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8660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3028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583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211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444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134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7183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0657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8B937-3AF9-BF46-8F07-84A4369BAD49}" type="datetimeFigureOut">
              <a:rPr lang="it-IT" smtClean="0"/>
              <a:t>25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5F293-5EF3-A84C-A038-7785EEF6387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1713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id="{AAB66584-B5B4-8C4F-885C-B54BA82387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7270472"/>
              </p:ext>
            </p:extLst>
          </p:nvPr>
        </p:nvGraphicFramePr>
        <p:xfrm>
          <a:off x="839969" y="1420257"/>
          <a:ext cx="8244801" cy="4026096"/>
        </p:xfrm>
        <a:graphic>
          <a:graphicData uri="http://schemas.openxmlformats.org/drawingml/2006/table">
            <a:tbl>
              <a:tblPr firstRow="1" firstCol="1" bandRow="1"/>
              <a:tblGrid>
                <a:gridCol w="12301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838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52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52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052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069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069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60114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67754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 i="1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Quality indices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10 masl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200 masl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700 masl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 i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Legal limits or usual range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7754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GM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TP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GM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TP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GM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TP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Acidity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4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3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4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3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5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6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d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8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PV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5.0 ± 0.0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2 ± 0.08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4.0 ± 0.04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6.0 ± 0.0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4.0 ± 0.0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5.0 ± 0.0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20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K</a:t>
                      </a:r>
                      <a:r>
                        <a:rPr lang="en-GB" sz="1100" b="1" baseline="-25000">
                          <a:effectLst/>
                          <a:latin typeface="Times New Roman" charset="0"/>
                          <a:ea typeface="Times New Roman" charset="0"/>
                        </a:rPr>
                        <a:t>232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85 ± 0.0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89 ± 0.0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98 ± 0.0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d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83 ± 0.0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76 ± 0.0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64 ± 0.04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2.5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K</a:t>
                      </a:r>
                      <a:r>
                        <a:rPr lang="en-GB" sz="1100" b="1" baseline="-25000">
                          <a:effectLst/>
                          <a:latin typeface="Times New Roman" charset="0"/>
                          <a:ea typeface="Times New Roman" charset="0"/>
                        </a:rPr>
                        <a:t>27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5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6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22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7754">
                <a:tc gridSpan="8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 i="1">
                          <a:effectLst/>
                          <a:latin typeface="Times New Roman" charset="0"/>
                          <a:ea typeface="Times New Roman" charset="0"/>
                        </a:rPr>
                        <a:t>Fatty Acids </a:t>
                      </a:r>
                      <a:r>
                        <a:rPr lang="en-GB" sz="1100" b="1" i="1" dirty="0">
                          <a:effectLst/>
                          <a:latin typeface="Times New Roman" charset="0"/>
                          <a:ea typeface="Times New Roman" charset="0"/>
                        </a:rPr>
                        <a:t>composition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4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05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6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2.36 ± 0.2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3.96 ± 0.2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2.01 ± 0.2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1.7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2.25 ± 0.2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2.15 ± 0.2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5-20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6:1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25 ± 0.1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29 ± 0.1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94 ± 0.1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93 ± 0.1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41 ± 0.1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79 ± 0.1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3-3.5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7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2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3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7:1 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3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3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8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2.60 ± 0.2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2.40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69 ± 0.1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75 ± 0.1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2.55 ± 0.2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.73 ± 0.17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5-5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8:1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6.17 ± 0.5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0.9 ± 0.5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4.65 ± 0.5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7.84 ± 0.5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d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4.66 ± 0.5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6.42 ± 0.58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55-83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8:2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5.78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8.72 ± 0.1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8.60 ± 0.18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5.97 ± 0.18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6.78 ± 0.17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6.71 ± 0.2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3.5-21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20:0 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51 ± 0.0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0.51 ± 0.05</a:t>
                      </a:r>
                      <a:r>
                        <a:rPr lang="en-GB" sz="1100" baseline="30000" dirty="0"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0.44 ± 0.03</a:t>
                      </a:r>
                      <a:r>
                        <a:rPr lang="en-GB" sz="1100" baseline="30000" dirty="0"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0.39 ± 0.03</a:t>
                      </a:r>
                      <a:r>
                        <a:rPr lang="en-GB" sz="1100" baseline="30000" dirty="0"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0.51 ± 0.04</a:t>
                      </a:r>
                      <a:r>
                        <a:rPr lang="en-GB" sz="1100" baseline="30000" dirty="0"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0.29 ± 0.01</a:t>
                      </a:r>
                      <a:r>
                        <a:rPr lang="en-GB" sz="1100" baseline="30000" dirty="0"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 charset="0"/>
                          <a:ea typeface="Times New Roman" charset="0"/>
                        </a:rPr>
                        <a:t>≤ 0.6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8:3 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82 ± 0.0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89 ± 0.04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99 ± 0.0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85 ± 0.0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95 ± 0.0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99 ± 0.0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1.0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20:1 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4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1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5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6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8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4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22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9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 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2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24:0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6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9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9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10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6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0.04 ± 0.0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≤ 0.2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ΣMUFAs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7.6 ± 0.5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2.4 ± 0.4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5.7 ± 0.48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8.8 ± 0.5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d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6.2 ± 0.5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7.3 ± 0.51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 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ΣPUFAs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6.60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9.61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9.59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6.82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73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70 ± 0.1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 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MUFAs/PUFAs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1.75 ± 0.3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53 ± 0.32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7.89 ± 0.34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1.56 ± 0.3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9.85 ± 0.3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0.04 ± 0.35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 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775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Times New Roman" charset="0"/>
                          <a:ea typeface="Times New Roman" charset="0"/>
                        </a:rPr>
                        <a:t>C18:1/C18:2</a:t>
                      </a:r>
                      <a:endParaRPr lang="it-IT" sz="11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3.17 ± 0.3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8.13 ± 0.33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8.68 ± 0.37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a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3.03 ± 0.39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c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1.01 ± 0.36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11.39 ± 0.40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b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</a:rPr>
                        <a:t> &gt; 7</a:t>
                      </a:r>
                      <a:endParaRPr lang="it-IT" sz="11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39707" marR="39707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8" name="Rettangolo 7">
            <a:extLst>
              <a:ext uri="{FF2B5EF4-FFF2-40B4-BE49-F238E27FC236}">
                <a16:creationId xmlns:a16="http://schemas.microsoft.com/office/drawing/2014/main" id="{B29B7A5B-D442-FB4F-B473-F2C0B9443B9B}"/>
              </a:ext>
            </a:extLst>
          </p:cNvPr>
          <p:cNvSpPr/>
          <p:nvPr/>
        </p:nvSpPr>
        <p:spPr>
          <a:xfrm>
            <a:off x="7325291" y="5485265"/>
            <a:ext cx="194516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>
                <a:latin typeface="Times New Roman" charset="0"/>
                <a:ea typeface="Times New Roman" charset="0"/>
              </a:rPr>
              <a:t>Additional file3: </a:t>
            </a:r>
            <a:r>
              <a:rPr lang="en-GB" sz="1200" b="1" dirty="0">
                <a:latin typeface="Times New Roman" charset="0"/>
                <a:ea typeface="Times New Roman" charset="0"/>
              </a:rPr>
              <a:t>Table S2</a:t>
            </a:r>
            <a:endParaRPr lang="it-IT" sz="1200" dirty="0">
              <a:latin typeface="Times New Roman" charset="0"/>
              <a:ea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06841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459</Words>
  <Application>Microsoft Macintosh PowerPoint</Application>
  <PresentationFormat>A4 (21x29,7 cm)</PresentationFormat>
  <Paragraphs>18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Utente di Microsoft Office</cp:lastModifiedBy>
  <cp:revision>7</cp:revision>
  <dcterms:created xsi:type="dcterms:W3CDTF">2018-10-03T10:37:59Z</dcterms:created>
  <dcterms:modified xsi:type="dcterms:W3CDTF">2018-10-25T14:46:57Z</dcterms:modified>
</cp:coreProperties>
</file>